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3" r:id="rId3"/>
    <p:sldId id="262" r:id="rId4"/>
    <p:sldId id="261" r:id="rId5"/>
    <p:sldId id="264" r:id="rId6"/>
    <p:sldId id="265" r:id="rId7"/>
    <p:sldId id="266" r:id="rId8"/>
    <p:sldId id="267" r:id="rId9"/>
    <p:sldId id="256" r:id="rId10"/>
    <p:sldId id="257" r:id="rId11"/>
    <p:sldId id="259" r:id="rId12"/>
    <p:sldId id="25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45E6FD-42EA-42D2-AEA0-B8BDF5A10B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32A7DE-2441-49AD-A8FA-B4C2917838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0242E7-4799-470F-A90C-E076AA3D2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9B3362-DD62-45A9-AFDA-A4D283676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70DF42-316F-4B17-8776-4F4BD47AA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170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02D906-62FB-4A28-A2D6-9EDBB37974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46AA75-C0FE-43A6-A809-181516D134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0B9BF0-6A22-4071-BA63-9A7E61D61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441B76-6873-473F-9D59-312EC720D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29FA09-3F3D-40BE-89F5-FE4B6AA72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870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C22D87-FF95-40A0-9FE2-EBE36CBF18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3CE238-3D92-40F2-A8C1-9A4D770F3D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0F7693-D4C6-497B-A299-DFAD21597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3DEAA5-ECF9-4991-AAC8-DEDA8E540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B98AA6-85A3-4742-88BA-4A88F4236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68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4FF15-4F9A-43A7-9FB5-271C04B6DB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2B05DD-43A6-45F3-BDFF-E22943EC9F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6677CD-CD14-479C-B44E-356A9B1A0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AA8A9-DC54-4F56-B624-BCE97699B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E81BF3-0CEF-4E9A-A35A-C107C862E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25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FDBD0-2B4D-4EC3-9E61-C4D836CEED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21B0C-7AAA-4153-9A9C-D41A816E8B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E9F0A-FEE3-4522-9103-08960916B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5B33BF-560F-4BC6-BA15-9C110FBCC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EB8FC4-C48E-4F1B-8F74-EC4D33A86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013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1F84F-6A36-46DE-8CF7-4A9FF9F14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0DB84F-E098-4E2D-812F-488B9C1C74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22AE84-240A-4580-9A36-4F03E2EDDC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4C37B2-B0DE-4512-A2A5-BD37C9348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4484D8-9E27-47A1-BA5C-4443E3564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76FA64-5662-4176-9398-9E84223C5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581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BC0FE-6775-4B26-8BF0-CE18847E8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C6A23D-3A24-4D78-96B2-D1D2FF8B28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65ADAE-1F22-438C-B594-7FAD5E0B96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38D779D-0182-4A21-8AAF-961E012A9D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3E5320-68DE-484F-98FD-1BE90B573F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80CD40-90FA-4596-8E92-55BE30127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7B2BB4-AEBB-4930-975B-C12A1EA47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662832-BF54-4055-BD94-2DDC37D2F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559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A7136-E1BE-46A9-94C4-EB75D1F8F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25A1F2-DC03-4D44-94C0-9C68B2065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E2C41A-E4DD-4A57-84D7-E08CCA6F3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60A815-7F78-4AFC-B5BB-77020DBCA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942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D3CD1A-877F-4117-A72B-16AE940EC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37F995-157E-4F59-8968-CF1DB1F83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3B14DD-F09F-41D7-890A-170B9ED0A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197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748AE-D0AB-4C06-9812-97A6B14FA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25A2C9-1F08-4E8E-A254-98B511C402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045E9C-A5A7-444C-8CAF-0F200A314C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23644B-7788-4CB3-9788-6872573B0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CECF41-E748-4855-978B-2C519AE74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922E01-F4A4-47D3-8BD2-11F97EF2F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201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88F11-D19F-4357-8F70-1ED3F4E56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8D9D97-14E5-48A6-B439-FEF2F28133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EB05EE-D0EC-4421-B686-41D0579357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1A9B86-846D-4449-B571-6532E7B0E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669DC5-B6E9-43E7-9FBB-4278ADF7A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1F4ACA-5AE4-47A1-BEB5-937EA0490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95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142303-99C1-4FA4-8D0B-A0DEF4A0F0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DA0F8F-2066-42DF-83A3-0E494B3DE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E2013-14A9-42BD-8F4A-33D9552D71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6717C-CAC4-433F-BBDC-CD9C6E326606}" type="datetimeFigureOut">
              <a:rPr lang="en-US" smtClean="0"/>
              <a:t>12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0492AF-8B2C-44B6-96A1-2117C41144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76C671-F09D-4288-A9DE-FA3ADC63C7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EE6BC-04AA-4260-99D0-24A48D80F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601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">
            <a:extLst>
              <a:ext uri="{FF2B5EF4-FFF2-40B4-BE49-F238E27FC236}">
                <a16:creationId xmlns:a16="http://schemas.microsoft.com/office/drawing/2014/main" id="{13674A84-5269-4911-9453-7041D759B5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CF2C94-158B-4C56-AA17-259F60B0ABDF}"/>
              </a:ext>
            </a:extLst>
          </p:cNvPr>
          <p:cNvSpPr txBox="1"/>
          <p:nvPr/>
        </p:nvSpPr>
        <p:spPr>
          <a:xfrm>
            <a:off x="178776" y="5708032"/>
            <a:ext cx="11646877" cy="10884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In silico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 expression profiles of the eight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s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Arabidopsis organs/ tissues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aport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heng et al., 2016) utilizes 113 public RNA-seq data sets along with annotation contributions from NCBI,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Pro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labs conducting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abidopsis thalia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earch to obtain gene expression values based on transcript abundance normalized in accordance with a reference gene in the experiment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close up of a pencil&#10;&#10;Description automatically generated">
            <a:extLst>
              <a:ext uri="{FF2B5EF4-FFF2-40B4-BE49-F238E27FC236}">
                <a16:creationId xmlns:a16="http://schemas.microsoft.com/office/drawing/2014/main" id="{7B0ACB46-B85D-4316-AE97-8F40A35BE9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2458" y="576275"/>
            <a:ext cx="8264015" cy="4998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54095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8">
            <a:extLst>
              <a:ext uri="{FF2B5EF4-FFF2-40B4-BE49-F238E27FC236}">
                <a16:creationId xmlns:a16="http://schemas.microsoft.com/office/drawing/2014/main" id="{4BD6F2B6-89E2-4DF6-BE41-64AF05F676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3906495"/>
              </p:ext>
            </p:extLst>
          </p:nvPr>
        </p:nvGraphicFramePr>
        <p:xfrm>
          <a:off x="2871757" y="1117161"/>
          <a:ext cx="6799780" cy="4828667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03449">
                  <a:extLst>
                    <a:ext uri="{9D8B030D-6E8A-4147-A177-3AD203B41FA5}">
                      <a16:colId xmlns:a16="http://schemas.microsoft.com/office/drawing/2014/main" val="3951767242"/>
                    </a:ext>
                  </a:extLst>
                </a:gridCol>
                <a:gridCol w="1158845">
                  <a:extLst>
                    <a:ext uri="{9D8B030D-6E8A-4147-A177-3AD203B41FA5}">
                      <a16:colId xmlns:a16="http://schemas.microsoft.com/office/drawing/2014/main" val="1620463295"/>
                    </a:ext>
                  </a:extLst>
                </a:gridCol>
                <a:gridCol w="2837207">
                  <a:extLst>
                    <a:ext uri="{9D8B030D-6E8A-4147-A177-3AD203B41FA5}">
                      <a16:colId xmlns:a16="http://schemas.microsoft.com/office/drawing/2014/main" val="293478836"/>
                    </a:ext>
                  </a:extLst>
                </a:gridCol>
                <a:gridCol w="946321">
                  <a:extLst>
                    <a:ext uri="{9D8B030D-6E8A-4147-A177-3AD203B41FA5}">
                      <a16:colId xmlns:a16="http://schemas.microsoft.com/office/drawing/2014/main" val="2917781568"/>
                    </a:ext>
                  </a:extLst>
                </a:gridCol>
                <a:gridCol w="953958">
                  <a:extLst>
                    <a:ext uri="{9D8B030D-6E8A-4147-A177-3AD203B41FA5}">
                      <a16:colId xmlns:a16="http://schemas.microsoft.com/office/drawing/2014/main" val="1137685866"/>
                    </a:ext>
                  </a:extLst>
                </a:gridCol>
              </a:tblGrid>
              <a:tr h="264423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 to 3’)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size (bp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7309242"/>
                  </a:ext>
                </a:extLst>
              </a:tr>
              <a:tr h="26442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nt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-typ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7719616"/>
                  </a:ext>
                </a:extLst>
              </a:tr>
              <a:tr h="279656">
                <a:tc rowSpan="3"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2-2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TCTGCTATTGACCTGC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9-749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7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8233404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TCCTTATGCCAATG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1029529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656832"/>
                  </a:ext>
                </a:extLst>
              </a:tr>
              <a:tr h="279656">
                <a:tc rowSpan="3"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5-1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CACTTTCGACAATTT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0-820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7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0598420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ATTACATGGTTTTGCG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6668523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6451781"/>
                  </a:ext>
                </a:extLst>
              </a:tr>
              <a:tr h="279656">
                <a:tc rowSpan="3"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7-1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TTTATTGGGGTTTAGG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1-761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94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8827632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GGTTCTGAGAAGACTT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2881513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0836943"/>
                  </a:ext>
                </a:extLst>
              </a:tr>
              <a:tr h="279656">
                <a:tc rowSpan="3"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8-1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TCTGTTAGACCGAA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9-799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4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0525650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AGGTTATGGCAAGATG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9016739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ctr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207528"/>
                  </a:ext>
                </a:extLst>
              </a:tr>
              <a:tr h="279656">
                <a:tc rowSpan="3"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9-1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TTACCTCCGACTTGT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7-777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2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9887005"/>
                  </a:ext>
                </a:extLst>
              </a:tr>
              <a:tr h="2796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50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40404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TCATCCACCGTAAGAA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407368"/>
                  </a:ext>
                </a:extLst>
              </a:tr>
              <a:tr h="320857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1.3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TTGCCGATTTCGGAAC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626347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F5CDC05-9DA2-4909-83F4-051DC18FEC61}"/>
              </a:ext>
            </a:extLst>
          </p:cNvPr>
          <p:cNvSpPr txBox="1"/>
          <p:nvPr/>
        </p:nvSpPr>
        <p:spPr>
          <a:xfrm>
            <a:off x="2222256" y="569386"/>
            <a:ext cx="8917598" cy="3427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. Oligonucleotides used for genotyping of the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0C4896-8EFB-4D9A-B8F2-4890D789B8C7}"/>
              </a:ext>
            </a:extLst>
          </p:cNvPr>
          <p:cNvSpPr txBox="1"/>
          <p:nvPr/>
        </p:nvSpPr>
        <p:spPr>
          <a:xfrm>
            <a:off x="2688248" y="5898070"/>
            <a:ext cx="6097464" cy="339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*LBb1.3 is a T-DNA left border-specific primer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1765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2B1DBF8-F75F-4D2D-AAC3-4F65C71CF84A}"/>
              </a:ext>
            </a:extLst>
          </p:cNvPr>
          <p:cNvSpPr txBox="1"/>
          <p:nvPr/>
        </p:nvSpPr>
        <p:spPr>
          <a:xfrm>
            <a:off x="1267816" y="599949"/>
            <a:ext cx="9656367" cy="5145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3. Oligonucleotide sequences used for </a:t>
            </a:r>
            <a:r>
              <a:rPr lang="en-US" sz="16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CR of the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ant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E5B9E10-1755-4E08-B867-F0E06E207F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8561040"/>
              </p:ext>
            </p:extLst>
          </p:nvPr>
        </p:nvGraphicFramePr>
        <p:xfrm>
          <a:off x="2681150" y="1468380"/>
          <a:ext cx="5617029" cy="332447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70674">
                  <a:extLst>
                    <a:ext uri="{9D8B030D-6E8A-4147-A177-3AD203B41FA5}">
                      <a16:colId xmlns:a16="http://schemas.microsoft.com/office/drawing/2014/main" val="2096030544"/>
                    </a:ext>
                  </a:extLst>
                </a:gridCol>
                <a:gridCol w="1179446">
                  <a:extLst>
                    <a:ext uri="{9D8B030D-6E8A-4147-A177-3AD203B41FA5}">
                      <a16:colId xmlns:a16="http://schemas.microsoft.com/office/drawing/2014/main" val="571840431"/>
                    </a:ext>
                  </a:extLst>
                </a:gridCol>
                <a:gridCol w="3166909">
                  <a:extLst>
                    <a:ext uri="{9D8B030D-6E8A-4147-A177-3AD203B41FA5}">
                      <a16:colId xmlns:a16="http://schemas.microsoft.com/office/drawing/2014/main" val="3435269428"/>
                    </a:ext>
                  </a:extLst>
                </a:gridCol>
              </a:tblGrid>
              <a:tr h="302225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to 3’)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582733"/>
                  </a:ext>
                </a:extLst>
              </a:tr>
              <a:tr h="302225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2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GCCTGTGGGATAATTTGT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0555054"/>
                  </a:ext>
                </a:extLst>
              </a:tr>
              <a:tr h="3022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CTAGCACCAAAGAGGA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2423631"/>
                  </a:ext>
                </a:extLst>
              </a:tr>
              <a:tr h="302225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5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AGTTCCCGATGGGCCTG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0821062"/>
                  </a:ext>
                </a:extLst>
              </a:tr>
              <a:tr h="3022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CCCCAAAATACTCCGCT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1743917"/>
                  </a:ext>
                </a:extLst>
              </a:tr>
              <a:tr h="302225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7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TTCTCAGAACCGAACCAC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6085821"/>
                  </a:ext>
                </a:extLst>
              </a:tr>
              <a:tr h="3022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CACAAACCATGAACCCG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3908200"/>
                  </a:ext>
                </a:extLst>
              </a:tr>
              <a:tr h="302225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8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AATGGTATGAGCCTGAGT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7946249"/>
                  </a:ext>
                </a:extLst>
              </a:tr>
              <a:tr h="3022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TTGCCTGGACGCCAAT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094268"/>
                  </a:ext>
                </a:extLst>
              </a:tr>
              <a:tr h="302225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9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TGCTGAAGAGGGAGGGA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0804357"/>
                  </a:ext>
                </a:extLst>
              </a:tr>
              <a:tr h="302225">
                <a:tc vMerge="1"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r>
                        <a:rPr lang="en-US" sz="12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TGAACACCAATCATCCAAGA</a:t>
                      </a:r>
                      <a:endParaRPr lang="en-US" sz="1200" b="0" i="0" u="none" strike="noStrike" dirty="0">
                        <a:solidFill>
                          <a:srgbClr val="222222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13757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279529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8ED8274-9016-4A7D-8212-B470E991C120}"/>
              </a:ext>
            </a:extLst>
          </p:cNvPr>
          <p:cNvSpPr txBox="1"/>
          <p:nvPr/>
        </p:nvSpPr>
        <p:spPr>
          <a:xfrm>
            <a:off x="1765055" y="648266"/>
            <a:ext cx="913667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4. 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IN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IN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display reduced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tal sugars (µg/mg seed ± SE) compared to WT in Arabidopsis seed mucilage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521554-FB9F-4F5C-8C42-040D89128634}"/>
              </a:ext>
            </a:extLst>
          </p:cNvPr>
          <p:cNvSpPr txBox="1"/>
          <p:nvPr/>
        </p:nvSpPr>
        <p:spPr>
          <a:xfrm>
            <a:off x="1765055" y="4526799"/>
            <a:ext cx="8302137" cy="11182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IN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act seeds were extracted sequentially with 0.2% ammonium oxalate, 0.2N NaOH, and 2N NaOH, neutralized and assayed with assayed with the phenol-sulfuric acid method against glucose standards. Experiment was performed twice where each experiment contained triplicates of all genotypes and results are given as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tandard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rror (SE). All genotypes were grown and harvested at the same tim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800"/>
              </a:spcAft>
            </a:pPr>
            <a:r>
              <a:rPr lang="en-IN" sz="12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variance (ANOVA) and post hoc Tukey test showed significant differences from WT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*, P &lt; 0.05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F658D70-C73F-4B5C-8B11-E6FCEB2FAB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5951729"/>
              </p:ext>
            </p:extLst>
          </p:nvPr>
        </p:nvGraphicFramePr>
        <p:xfrm>
          <a:off x="2349966" y="1450731"/>
          <a:ext cx="7064174" cy="3043012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805494">
                  <a:extLst>
                    <a:ext uri="{9D8B030D-6E8A-4147-A177-3AD203B41FA5}">
                      <a16:colId xmlns:a16="http://schemas.microsoft.com/office/drawing/2014/main" val="1041604455"/>
                    </a:ext>
                  </a:extLst>
                </a:gridCol>
                <a:gridCol w="1805494">
                  <a:extLst>
                    <a:ext uri="{9D8B030D-6E8A-4147-A177-3AD203B41FA5}">
                      <a16:colId xmlns:a16="http://schemas.microsoft.com/office/drawing/2014/main" val="958550987"/>
                    </a:ext>
                  </a:extLst>
                </a:gridCol>
                <a:gridCol w="1726593">
                  <a:extLst>
                    <a:ext uri="{9D8B030D-6E8A-4147-A177-3AD203B41FA5}">
                      <a16:colId xmlns:a16="http://schemas.microsoft.com/office/drawing/2014/main" val="1153813639"/>
                    </a:ext>
                  </a:extLst>
                </a:gridCol>
                <a:gridCol w="1726593">
                  <a:extLst>
                    <a:ext uri="{9D8B030D-6E8A-4147-A177-3AD203B41FA5}">
                      <a16:colId xmlns:a16="http://schemas.microsoft.com/office/drawing/2014/main" val="1647237692"/>
                    </a:ext>
                  </a:extLst>
                </a:gridCol>
              </a:tblGrid>
              <a:tr h="335413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type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 err="1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tract</a:t>
                      </a:r>
                      <a:r>
                        <a:rPr lang="en-IN" sz="1200" baseline="30000" dirty="0" err="1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3566453"/>
                  </a:ext>
                </a:extLst>
              </a:tr>
              <a:tr h="64479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% ammonium oxalate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N NaOH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solidFill>
                            <a:sysClr val="windowText" lastClr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N NaOH</a:t>
                      </a:r>
                      <a:endParaRPr lang="en-US" sz="1200" dirty="0">
                        <a:solidFill>
                          <a:sysClr val="windowText" lastClr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142062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34 ± 0.2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.45 ± 2.6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.82 ± 0.6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74816146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53 ± 0.8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7.80 ± 21.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.49 ± 2.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124825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9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17 ± 0.9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.27 ± 5.9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.03 ± 2.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49730151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9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64 ± 2.57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2.10 ± 4.81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.86 ± 2.1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6042728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8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47 ± 1.43</a:t>
                      </a:r>
                      <a:r>
                        <a:rPr lang="en-US" sz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2.84 ± 4.95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47 ± 2.97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30173516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9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06 ± 0.7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.69 ± 4.64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80 ± 1.9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4616499"/>
                  </a:ext>
                </a:extLst>
              </a:tr>
              <a:tr h="294686"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789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1280" marR="81280" marT="40640" marB="40640" anchor="ctr">
                    <a:lnL w="9525" cap="flat" cmpd="sng" algn="ctr">
                      <a:noFill/>
                      <a:prstDash val="soli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.43 ± 0.30</a:t>
                      </a:r>
                      <a:r>
                        <a:rPr lang="en-US" sz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.01 ± 4.66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9144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88 ± 1.65</a:t>
                      </a:r>
                      <a:r>
                        <a:rPr lang="en-US" sz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 w="9525" cap="flat" cmpd="sng" algn="ctr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784964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33388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C004726-6A5C-4E8E-9597-9C36D32CC8EF}"/>
              </a:ext>
            </a:extLst>
          </p:cNvPr>
          <p:cNvSpPr txBox="1"/>
          <p:nvPr/>
        </p:nvSpPr>
        <p:spPr>
          <a:xfrm>
            <a:off x="325949" y="6181426"/>
            <a:ext cx="116234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Gene expression analysis of the eight </a:t>
            </a:r>
            <a:r>
              <a:rPr lang="en-IN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IN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s during seed development. 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R </a:t>
            </a:r>
            <a:r>
              <a:rPr lang="en-IN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P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rowser (Lee et al., 2010) displays gene expression profiles based on laser-capture micro-dissected seeds during various stages of seed development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 Box 2">
            <a:extLst>
              <a:ext uri="{FF2B5EF4-FFF2-40B4-BE49-F238E27FC236}">
                <a16:creationId xmlns:a16="http://schemas.microsoft.com/office/drawing/2014/main" id="{453E4BA2-58D3-4E24-96EC-75A81F485A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168996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54F87E0-FF31-4FE8-A70B-057A28EBB10A}"/>
              </a:ext>
            </a:extLst>
          </p:cNvPr>
          <p:cNvGrpSpPr/>
          <p:nvPr/>
        </p:nvGrpSpPr>
        <p:grpSpPr>
          <a:xfrm>
            <a:off x="3754196" y="2664"/>
            <a:ext cx="4000619" cy="6205137"/>
            <a:chOff x="-193583" y="617521"/>
            <a:chExt cx="4892236" cy="8530527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F314E30-3579-4073-8C52-22755E741286}"/>
                </a:ext>
              </a:extLst>
            </p:cNvPr>
            <p:cNvGrpSpPr/>
            <p:nvPr/>
          </p:nvGrpSpPr>
          <p:grpSpPr>
            <a:xfrm>
              <a:off x="-193580" y="6106437"/>
              <a:ext cx="4827961" cy="3041611"/>
              <a:chOff x="4198958" y="974581"/>
              <a:chExt cx="4827961" cy="3041611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9B3EF0FE-C4AB-4A6D-8DDA-5EB295799D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32676" y="1057446"/>
                <a:ext cx="3247810" cy="880909"/>
              </a:xfrm>
              <a:prstGeom prst="rect">
                <a:avLst/>
              </a:prstGeom>
            </p:spPr>
          </p:pic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1FDE86E1-BCFA-41A0-B30A-06516766A4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631867" y="974581"/>
                <a:ext cx="395052" cy="927240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F0900300-F20D-456D-AE43-10DDA3B30B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645982" y="1941877"/>
                <a:ext cx="367184" cy="1076712"/>
              </a:xfrm>
              <a:prstGeom prst="rect">
                <a:avLst/>
              </a:prstGeom>
            </p:spPr>
          </p:pic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507A544A-D96A-4BDD-9B28-68F71B6C80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280602" y="2105945"/>
                <a:ext cx="3320168" cy="890715"/>
              </a:xfrm>
              <a:prstGeom prst="rect">
                <a:avLst/>
              </a:prstGeom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EF441C66-B1CC-418D-8C49-B32AF604B1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611169" y="3018098"/>
                <a:ext cx="411064" cy="998094"/>
              </a:xfrm>
              <a:prstGeom prst="rect">
                <a:avLst/>
              </a:prstGeom>
            </p:spPr>
          </p:pic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06964345-A6FC-497D-9A1E-258270F3E4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32676" y="3142886"/>
                <a:ext cx="3269562" cy="859217"/>
              </a:xfrm>
              <a:prstGeom prst="rect">
                <a:avLst/>
              </a:prstGeom>
            </p:spPr>
          </p:pic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8C9E1C8D-12F9-4E61-AB45-D90660485D4B}"/>
                  </a:ext>
                </a:extLst>
              </p:cNvPr>
              <p:cNvSpPr/>
              <p:nvPr/>
            </p:nvSpPr>
            <p:spPr>
              <a:xfrm>
                <a:off x="4198958" y="1145300"/>
                <a:ext cx="1250356" cy="501301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7/HPGT1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5g5334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1BF63D0D-F42F-474D-B96C-B494B153781A}"/>
                  </a:ext>
                </a:extLst>
              </p:cNvPr>
              <p:cNvSpPr/>
              <p:nvPr/>
            </p:nvSpPr>
            <p:spPr>
              <a:xfrm>
                <a:off x="4200842" y="2156145"/>
                <a:ext cx="1246878" cy="478149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8/HPGT2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4g3212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82467806-833D-40C0-855D-00EA22A7E2F2}"/>
                  </a:ext>
                </a:extLst>
              </p:cNvPr>
              <p:cNvSpPr/>
              <p:nvPr/>
            </p:nvSpPr>
            <p:spPr>
              <a:xfrm>
                <a:off x="4208900" y="3223639"/>
                <a:ext cx="1340089" cy="505606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9/HPGT3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2g2530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40C40E0-9230-4C5C-A676-715B588BD4C7}"/>
                </a:ext>
              </a:extLst>
            </p:cNvPr>
            <p:cNvGrpSpPr/>
            <p:nvPr/>
          </p:nvGrpSpPr>
          <p:grpSpPr>
            <a:xfrm>
              <a:off x="-193583" y="617521"/>
              <a:ext cx="4892236" cy="5411475"/>
              <a:chOff x="-193583" y="617521"/>
              <a:chExt cx="4892236" cy="5411475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69171DC-28CD-4E58-97BC-133C4CF3BA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88064" y="1066846"/>
                <a:ext cx="3382921" cy="876482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8A806884-96F6-4CDB-B7E0-BE78873F9E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19673" y="2051179"/>
                <a:ext cx="3389617" cy="910923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79C41317-EC40-4815-A4EB-A04A69C71A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73655" y="1965333"/>
                <a:ext cx="524998" cy="105166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BF3B3931-E9F4-4EE5-9BB0-FD9D7C7CE3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99689" y="3111440"/>
                <a:ext cx="3377961" cy="863750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5F3775EB-A0FD-4DA9-AD83-F5F63EE020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43994" y="3028458"/>
                <a:ext cx="418398" cy="997983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29D2F6F1-19C9-4BCE-A675-7670AD654F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86671" y="973163"/>
                <a:ext cx="498908" cy="992169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5405BD3-1392-48EE-99F4-BF7F85E14B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13059" y="4102902"/>
                <a:ext cx="3404744" cy="866304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4C54B59A-E5E6-4B08-9805-6D10E602371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62819" y="4048728"/>
                <a:ext cx="390048" cy="942401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D682A1EC-8953-4C28-BB67-2BE23CAB97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226565" y="5029984"/>
                <a:ext cx="440647" cy="999012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F0157295-6F22-4492-BB13-69FFB7781A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54540" y="5112584"/>
                <a:ext cx="3409662" cy="867521"/>
              </a:xfrm>
              <a:prstGeom prst="rect">
                <a:avLst/>
              </a:prstGeom>
            </p:spPr>
          </p:pic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800B413E-6940-4EED-832D-E17545489200}"/>
                  </a:ext>
                </a:extLst>
              </p:cNvPr>
              <p:cNvSpPr/>
              <p:nvPr/>
            </p:nvSpPr>
            <p:spPr>
              <a:xfrm>
                <a:off x="-193582" y="1185589"/>
                <a:ext cx="1244270" cy="436209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2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4g2106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03A5751D-3455-4CC6-8C65-DB2FDCF9C5F8}"/>
                  </a:ext>
                </a:extLst>
              </p:cNvPr>
              <p:cNvSpPr/>
              <p:nvPr/>
            </p:nvSpPr>
            <p:spPr>
              <a:xfrm>
                <a:off x="-189511" y="2196628"/>
                <a:ext cx="1200133" cy="507618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3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3g0644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6E63B262-FAA8-45FB-A467-3E31C631D5F0}"/>
                  </a:ext>
                </a:extLst>
              </p:cNvPr>
              <p:cNvSpPr/>
              <p:nvPr/>
            </p:nvSpPr>
            <p:spPr>
              <a:xfrm>
                <a:off x="-183219" y="3209746"/>
                <a:ext cx="1280210" cy="480369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4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1g2712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044DAE97-E5B9-4A57-B9ED-F80DB85900CC}"/>
                  </a:ext>
                </a:extLst>
              </p:cNvPr>
              <p:cNvSpPr/>
              <p:nvPr/>
            </p:nvSpPr>
            <p:spPr>
              <a:xfrm>
                <a:off x="-193583" y="4186297"/>
                <a:ext cx="1211034" cy="593849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5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1g7480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A56F2CBC-DCE1-4FEE-853C-1F337E9766FA}"/>
                  </a:ext>
                </a:extLst>
              </p:cNvPr>
              <p:cNvSpPr/>
              <p:nvPr/>
            </p:nvSpPr>
            <p:spPr>
              <a:xfrm>
                <a:off x="-193583" y="5249307"/>
                <a:ext cx="1133720" cy="532244"/>
              </a:xfrm>
              <a:prstGeom prst="rect">
                <a:avLst/>
              </a:prstGeom>
            </p:spPr>
            <p:txBody>
              <a:bodyPr wrap="square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LT6 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IN" sz="1100" b="1" i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(At5g62620)</a:t>
                </a:r>
                <a:endParaRPr lang="en-US" sz="1200" i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562D1B39-84D3-4002-8F68-7176DE6DAC4D}"/>
                  </a:ext>
                </a:extLst>
              </p:cNvPr>
              <p:cNvGrpSpPr/>
              <p:nvPr/>
            </p:nvGrpSpPr>
            <p:grpSpPr>
              <a:xfrm>
                <a:off x="752725" y="617521"/>
                <a:ext cx="3598270" cy="513264"/>
                <a:chOff x="-55929" y="-63384"/>
                <a:chExt cx="3631075" cy="470862"/>
              </a:xfrm>
            </p:grpSpPr>
            <p:sp>
              <p:nvSpPr>
                <p:cNvPr id="24" name="Text Box 2">
                  <a:extLst>
                    <a:ext uri="{FF2B5EF4-FFF2-40B4-BE49-F238E27FC236}">
                      <a16:creationId xmlns:a16="http://schemas.microsoft.com/office/drawing/2014/main" id="{01C57D1E-2574-4DCC-BE0F-3897038C0E0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55929" y="19844"/>
                  <a:ext cx="1037388" cy="3125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IN" sz="900" b="1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Pre-globular </a:t>
                  </a:r>
                  <a:endParaRPr lang="en-US" sz="9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Text Box 2">
                  <a:extLst>
                    <a:ext uri="{FF2B5EF4-FFF2-40B4-BE49-F238E27FC236}">
                      <a16:creationId xmlns:a16="http://schemas.microsoft.com/office/drawing/2014/main" id="{2B85EB5C-F6BE-42F6-BC31-2C88CD8073B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75069" y="26413"/>
                  <a:ext cx="752793" cy="3810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IN" sz="900" b="1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Globular </a:t>
                  </a:r>
                  <a:endParaRPr lang="en-US" sz="9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Text Box 2">
                  <a:extLst>
                    <a:ext uri="{FF2B5EF4-FFF2-40B4-BE49-F238E27FC236}">
                      <a16:creationId xmlns:a16="http://schemas.microsoft.com/office/drawing/2014/main" id="{5F2A4E18-83EC-4C6A-9A14-7969DA1D0DC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513430" y="40214"/>
                  <a:ext cx="617855" cy="30099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IN" sz="900" b="1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Heart </a:t>
                  </a:r>
                  <a:endParaRPr lang="en-US" sz="9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Text Box 2">
                  <a:extLst>
                    <a:ext uri="{FF2B5EF4-FFF2-40B4-BE49-F238E27FC236}">
                      <a16:creationId xmlns:a16="http://schemas.microsoft.com/office/drawing/2014/main" id="{92DDBC2B-4954-4AA2-AC06-5DC2AEF6E13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908893" y="-63384"/>
                  <a:ext cx="960755" cy="4102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IN" sz="900" b="1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Linear cotyledon</a:t>
                  </a:r>
                  <a:endParaRPr lang="en-US" sz="9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Text Box 2">
                  <a:extLst>
                    <a:ext uri="{FF2B5EF4-FFF2-40B4-BE49-F238E27FC236}">
                      <a16:creationId xmlns:a16="http://schemas.microsoft.com/office/drawing/2014/main" id="{41E520C6-CA7C-42E5-B51E-49736AD7F81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614392" y="-55660"/>
                  <a:ext cx="960754" cy="4102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900" b="1" dirty="0">
                      <a:effectLst/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Maturation green</a:t>
                  </a:r>
                  <a:endParaRPr lang="en-US" sz="900" dirty="0">
                    <a:effectLst/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9643115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B46D9D40-35E7-4EDA-B723-8F82E5DE69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0B2C1F-C504-4E39-8BCB-CA18D52471C0}"/>
              </a:ext>
            </a:extLst>
          </p:cNvPr>
          <p:cNvSpPr txBox="1"/>
          <p:nvPr/>
        </p:nvSpPr>
        <p:spPr>
          <a:xfrm>
            <a:off x="240052" y="5534561"/>
            <a:ext cx="11790485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629920" algn="l"/>
              </a:tabLs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. Growth phenotype of WT and higher-order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on soil. A.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T and mutant seedlings were sown on ½ MS media and transferred to soil at 10 DAG; photos were taken over a period of four weeks on soil. Rosette sizes of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89, 2578, 2579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5789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smaller than wild type throughout the 4 weeks.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otal number of rosette leaves were counted for mutants and WT plants after the main stem bolted 1 cm. Data for number of rosette leaves are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s±SE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measurements from three independent experiments (total n=50). An analysis of variance (ANOVA) on these mutants yielded no significant variation among conditions. DAG, days after germination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02F1166B-4AF2-4DB9-965B-ECC75641905C}"/>
              </a:ext>
            </a:extLst>
          </p:cNvPr>
          <p:cNvGrpSpPr/>
          <p:nvPr/>
        </p:nvGrpSpPr>
        <p:grpSpPr>
          <a:xfrm>
            <a:off x="3130062" y="178948"/>
            <a:ext cx="6198576" cy="5406518"/>
            <a:chOff x="1278751" y="547947"/>
            <a:chExt cx="6380051" cy="5610683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A4B24D8B-9CA5-4054-833D-4E257B28D15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85198" y="569777"/>
              <a:ext cx="6173604" cy="2748032"/>
            </a:xfrm>
            <a:prstGeom prst="rect">
              <a:avLst/>
            </a:prstGeom>
          </p:spPr>
        </p:pic>
        <p:pic>
          <p:nvPicPr>
            <p:cNvPr id="46" name="Picture 45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F29E0E18-897D-4A6C-B12E-D23BCC7BC6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1017"/>
            <a:stretch/>
          </p:blipFill>
          <p:spPr>
            <a:xfrm>
              <a:off x="2792677" y="3614533"/>
              <a:ext cx="3743096" cy="2544097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1A20711-8E94-402D-8BDE-D9B72084373B}"/>
                </a:ext>
              </a:extLst>
            </p:cNvPr>
            <p:cNvSpPr txBox="1"/>
            <p:nvPr/>
          </p:nvSpPr>
          <p:spPr>
            <a:xfrm>
              <a:off x="2509102" y="3525324"/>
              <a:ext cx="56715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B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28A31CF-7F2E-404E-94BC-94B315E268B6}"/>
                </a:ext>
              </a:extLst>
            </p:cNvPr>
            <p:cNvSpPr txBox="1"/>
            <p:nvPr/>
          </p:nvSpPr>
          <p:spPr>
            <a:xfrm>
              <a:off x="1278751" y="547947"/>
              <a:ext cx="56715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58624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73EC61E7-B73C-4D1B-82C7-10C46A99A2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D53C63-1AD2-4BF7-A35E-3811008F1384}"/>
              </a:ext>
            </a:extLst>
          </p:cNvPr>
          <p:cNvSpPr txBox="1"/>
          <p:nvPr/>
        </p:nvSpPr>
        <p:spPr>
          <a:xfrm>
            <a:off x="167054" y="5288340"/>
            <a:ext cx="11746523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629920" algn="l"/>
              </a:tabLs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. Quantification of root hair length and root hair density of wild type and higher-order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on ½ MS media at 7 DAG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for root hair length are means ± SE of measurements from three independent experiments (n=80). Data for root hair density are means ± SE of measurements from three independent experiments (total n=50). An analysis of variance (ANOVA) on these mutants yielded significant variation among conditions. A post hoc Tukey test was applied to see which groups were significantly different from wild type (Col-0). Asterisks indicate significantly reduced root hair length and density compared with WT. *P&lt; .05, **P&lt;0.005, ***P&lt;0.001. DAG, days after germination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43E2556-46E3-4D63-9C64-0344AB6775CE}"/>
              </a:ext>
            </a:extLst>
          </p:cNvPr>
          <p:cNvGrpSpPr/>
          <p:nvPr/>
        </p:nvGrpSpPr>
        <p:grpSpPr>
          <a:xfrm>
            <a:off x="3804775" y="238983"/>
            <a:ext cx="3782986" cy="5049357"/>
            <a:chOff x="1861032" y="342902"/>
            <a:chExt cx="4715842" cy="6109119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017A4B5-E0C7-4B12-A11A-47764B958A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14482" y="3402623"/>
              <a:ext cx="4262392" cy="304939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DC95F61-2DE9-418A-BBF8-54961F37AAF5}"/>
                </a:ext>
              </a:extLst>
            </p:cNvPr>
            <p:cNvSpPr txBox="1"/>
            <p:nvPr/>
          </p:nvSpPr>
          <p:spPr>
            <a:xfrm>
              <a:off x="1861032" y="342902"/>
              <a:ext cx="50409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93BC076-0A31-4631-AF60-65F4932B86AB}"/>
                </a:ext>
              </a:extLst>
            </p:cNvPr>
            <p:cNvSpPr txBox="1"/>
            <p:nvPr/>
          </p:nvSpPr>
          <p:spPr>
            <a:xfrm>
              <a:off x="1861032" y="3420207"/>
              <a:ext cx="50409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b="1" dirty="0"/>
                <a:t>B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68B8ED25-011A-4AF1-A8AC-6F3EAB29050B}"/>
                </a:ext>
              </a:extLst>
            </p:cNvPr>
            <p:cNvGrpSpPr/>
            <p:nvPr/>
          </p:nvGrpSpPr>
          <p:grpSpPr>
            <a:xfrm>
              <a:off x="2244146" y="473819"/>
              <a:ext cx="4262392" cy="2902429"/>
              <a:chOff x="1402741" y="3207727"/>
              <a:chExt cx="5085984" cy="3471850"/>
            </a:xfrm>
          </p:grpSpPr>
          <p:pic>
            <p:nvPicPr>
              <p:cNvPr id="12" name="Picture 11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13491A7F-993B-45FA-8787-BECEE739C9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11402"/>
              <a:stretch/>
            </p:blipFill>
            <p:spPr>
              <a:xfrm>
                <a:off x="1402741" y="3207727"/>
                <a:ext cx="5085984" cy="3471850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3074DA7-A5C1-4B5E-9D58-34FD5FC2EABD}"/>
                  </a:ext>
                </a:extLst>
              </p:cNvPr>
              <p:cNvSpPr txBox="1"/>
              <p:nvPr/>
            </p:nvSpPr>
            <p:spPr>
              <a:xfrm>
                <a:off x="6000549" y="3524399"/>
                <a:ext cx="382990" cy="3681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87989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B95C214D-F02E-4D33-B78A-AC58CB9CA5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260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6708FB2-379E-4355-BB04-DC1A09567F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0731" y="1890346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D726DDDF-F0CD-4B74-B5F7-F3711C5F9C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4529" y="204165"/>
            <a:ext cx="4223537" cy="5509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6302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630238" algn="l"/>
              </a:tabLst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. Salt induced inhibition of vertically grown primary roots of WT and higher-order </a:t>
            </a:r>
            <a:r>
              <a:rPr kumimoji="0" lang="en-US" altLang="en-US" sz="1600" b="1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kumimoji="0" lang="en-US" altLang="en-US" sz="1600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on ½ MS supplemented with 100 mM NaCl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edlings of WT and mutants were grown vertically on ½ MS media for 4 DAG and pictures were taken 7 days after transfer to ½ MS supplemented with 100 mM NaCl. Scale bar = 1 cm. </a:t>
            </a: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0 days after transfer to ½ MS supplemented with 100 mM NaCl. Scale bar = 1.0 mm. </a:t>
            </a: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oot elongation (i.e. increase in root length of 4-day-old seedlings after transfer onto ½ MS supplemented with 100 mM NaCl) was measured after 7, 14 and 21 days. Data are 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s±SE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measurements from three independent experiments (total n = 40). An analysis of variance (ANOVA) on these mutants yielded significant variation among conditions. A post hoc Tukey test was applied to see which groups were significantly different from WT. *P&lt; .05, **P&lt;0.005, ***P&lt;0.001. DAG, days after germination.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8BE184D-49E4-4293-B057-C759E038A702}"/>
              </a:ext>
            </a:extLst>
          </p:cNvPr>
          <p:cNvGrpSpPr/>
          <p:nvPr/>
        </p:nvGrpSpPr>
        <p:grpSpPr>
          <a:xfrm>
            <a:off x="2831123" y="252967"/>
            <a:ext cx="4872998" cy="6508318"/>
            <a:chOff x="1310055" y="64628"/>
            <a:chExt cx="6364484" cy="915607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0804F75-96BB-47EA-9437-57D46CE950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69461" y="5319337"/>
              <a:ext cx="6205078" cy="390137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98EBA49-C1FD-4BFF-AD8B-06FBC0F14E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64960" y="186642"/>
              <a:ext cx="5562602" cy="171518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1DF4A73-560D-42A3-8355-827017B3678A}"/>
                </a:ext>
              </a:extLst>
            </p:cNvPr>
            <p:cNvSpPr txBox="1"/>
            <p:nvPr/>
          </p:nvSpPr>
          <p:spPr>
            <a:xfrm>
              <a:off x="1409137" y="64628"/>
              <a:ext cx="525822" cy="632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6ADECE6-13BA-4273-AA17-C6F4F265B614}"/>
                </a:ext>
              </a:extLst>
            </p:cNvPr>
            <p:cNvSpPr txBox="1"/>
            <p:nvPr/>
          </p:nvSpPr>
          <p:spPr>
            <a:xfrm>
              <a:off x="1310055" y="1996440"/>
              <a:ext cx="305384" cy="632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B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760466B-2080-4F69-A2BB-F0E564102B9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64960" y="1970336"/>
              <a:ext cx="5562602" cy="299690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0B0738B-CAA5-4B0A-90C9-F9AF7982C459}"/>
                </a:ext>
              </a:extLst>
            </p:cNvPr>
            <p:cNvSpPr txBox="1"/>
            <p:nvPr/>
          </p:nvSpPr>
          <p:spPr>
            <a:xfrm>
              <a:off x="1310055" y="5324388"/>
              <a:ext cx="372296" cy="632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673620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4B07C600-4808-4138-9EBF-9A8F0756DF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6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9160A75-FE51-42AE-B846-532576760FD7}"/>
              </a:ext>
            </a:extLst>
          </p:cNvPr>
          <p:cNvSpPr txBox="1"/>
          <p:nvPr/>
        </p:nvSpPr>
        <p:spPr>
          <a:xfrm>
            <a:off x="315058" y="5730505"/>
            <a:ext cx="115618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6. 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seed set of the basal 15 siliques on the main inflorescence of the </a:t>
            </a:r>
            <a:r>
              <a:rPr lang="en-IN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IN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 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tants compared to WT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fifteen siliques (starting from the base) were used to quantify seed set in 45-days-old plants grown on soil. Data presented are </a:t>
            </a:r>
            <a:r>
              <a:rPr lang="en-US" sz="1600" dirty="0" err="1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600" dirty="0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 =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 plants in three independent experiments).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AE166A4D-5B38-4707-B30E-C819F17EA0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5177" y="614099"/>
            <a:ext cx="8953711" cy="5116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23925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35F3A04B-1FF0-4E8F-A466-52621A04A7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7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3711DE1-CE17-43D1-B80D-4BB6EEDAFD0F}"/>
              </a:ext>
            </a:extLst>
          </p:cNvPr>
          <p:cNvSpPr txBox="1"/>
          <p:nvPr/>
        </p:nvSpPr>
        <p:spPr>
          <a:xfrm>
            <a:off x="354623" y="5822838"/>
            <a:ext cx="1148275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629920" algn="l"/>
              </a:tabLs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7. 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silique lengths of the basal 15 siliques on the main inflorescence of the </a:t>
            </a:r>
            <a:r>
              <a:rPr lang="en-IN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IN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compared to WT. </a:t>
            </a:r>
            <a:r>
              <a:rPr lang="en-US" sz="1600" dirty="0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fifteen siliques (starting from the base were used to quantify silique length in 45-day-old plants grown on soil. Data presented are </a:t>
            </a:r>
            <a:r>
              <a:rPr lang="en-US" sz="1600" dirty="0" err="1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600" dirty="0">
                <a:solidFill>
                  <a:srgbClr val="323232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=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 plants from two independent experiments)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281C69A2-02FA-4299-AE7D-1C8AF37609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2423" y="576275"/>
            <a:ext cx="9134475" cy="5219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5750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85F666D5-8ED6-4323-AABB-FF738D0613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934" y="204165"/>
            <a:ext cx="2876128" cy="372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tabLst>
                <a:tab pos="629920" algn="l"/>
              </a:tabLst>
            </a:pPr>
            <a:r>
              <a:rPr lang="en-US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8. 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BB630F0-CC73-4CBA-8EB7-0BAB45B05DB6}"/>
              </a:ext>
            </a:extLst>
          </p:cNvPr>
          <p:cNvSpPr txBox="1"/>
          <p:nvPr/>
        </p:nvSpPr>
        <p:spPr>
          <a:xfrm>
            <a:off x="372208" y="5727630"/>
            <a:ext cx="114475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629920" algn="l"/>
              </a:tabLst>
            </a:pP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8.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gher-order </a:t>
            </a:r>
            <a:r>
              <a:rPr lang="en-US" sz="1600" b="1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p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GALT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flower morphology compared to WT flower morphology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5789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had smaller fertile flowers compared to WT, but the floral organization was similar (n=10 flowers from 5 plants each). Scale bar=1.0 mm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903507EB-4B99-403C-B01C-8583E6B2A7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2713" y="649240"/>
            <a:ext cx="5747710" cy="5091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31287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C0ED9AC-57E4-4467-B654-8ED86A8F13FD}"/>
              </a:ext>
            </a:extLst>
          </p:cNvPr>
          <p:cNvSpPr txBox="1"/>
          <p:nvPr/>
        </p:nvSpPr>
        <p:spPr>
          <a:xfrm>
            <a:off x="838672" y="127867"/>
            <a:ext cx="10514655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Table 1. 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formation on the </a:t>
            </a:r>
            <a:r>
              <a:rPr lang="en-IN" sz="16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yp</a:t>
            </a:r>
            <a:r>
              <a:rPr lang="en-IN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GALT enzymes, genes, and their genetic mutants. 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two independent </a:t>
            </a:r>
            <a:r>
              <a:rPr lang="en-IN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ALT2-6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-DNA lines have been characterised and they had same phenotypes as reported by </a:t>
            </a:r>
            <a:r>
              <a:rPr lang="en-IN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asu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(2015) [30] and </a:t>
            </a:r>
            <a:r>
              <a:rPr lang="en-IN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asu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(2015) [31]. The </a:t>
            </a:r>
            <a:r>
              <a:rPr lang="en-IN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ALT7-9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-DNA insertion lines were identified and confirmed by Ogawa-Ohnishi and </a:t>
            </a:r>
            <a:r>
              <a:rPr lang="en-IN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atsubayashi</a:t>
            </a:r>
            <a:r>
              <a:rPr lang="en-IN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2015) [32]. Also, the subcellular localization of GALT2-9 mentioned here were reported in these studies</a:t>
            </a:r>
            <a:endParaRPr lang="en-US" sz="1600" dirty="0"/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6EFEBAB8-DEE6-4C04-A2EA-655DAFC300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6052287"/>
              </p:ext>
            </p:extLst>
          </p:nvPr>
        </p:nvGraphicFramePr>
        <p:xfrm>
          <a:off x="1916722" y="1221294"/>
          <a:ext cx="8124093" cy="5025801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59344">
                  <a:extLst>
                    <a:ext uri="{9D8B030D-6E8A-4147-A177-3AD203B41FA5}">
                      <a16:colId xmlns:a16="http://schemas.microsoft.com/office/drawing/2014/main" val="1250801486"/>
                    </a:ext>
                  </a:extLst>
                </a:gridCol>
                <a:gridCol w="1072680">
                  <a:extLst>
                    <a:ext uri="{9D8B030D-6E8A-4147-A177-3AD203B41FA5}">
                      <a16:colId xmlns:a16="http://schemas.microsoft.com/office/drawing/2014/main" val="1053796232"/>
                    </a:ext>
                  </a:extLst>
                </a:gridCol>
                <a:gridCol w="1932672">
                  <a:extLst>
                    <a:ext uri="{9D8B030D-6E8A-4147-A177-3AD203B41FA5}">
                      <a16:colId xmlns:a16="http://schemas.microsoft.com/office/drawing/2014/main" val="1448446403"/>
                    </a:ext>
                  </a:extLst>
                </a:gridCol>
                <a:gridCol w="1051366">
                  <a:extLst>
                    <a:ext uri="{9D8B030D-6E8A-4147-A177-3AD203B41FA5}">
                      <a16:colId xmlns:a16="http://schemas.microsoft.com/office/drawing/2014/main" val="2364799723"/>
                    </a:ext>
                  </a:extLst>
                </a:gridCol>
                <a:gridCol w="1541857">
                  <a:extLst>
                    <a:ext uri="{9D8B030D-6E8A-4147-A177-3AD203B41FA5}">
                      <a16:colId xmlns:a16="http://schemas.microsoft.com/office/drawing/2014/main" val="3554521688"/>
                    </a:ext>
                  </a:extLst>
                </a:gridCol>
                <a:gridCol w="1166174">
                  <a:extLst>
                    <a:ext uri="{9D8B030D-6E8A-4147-A177-3AD203B41FA5}">
                      <a16:colId xmlns:a16="http://schemas.microsoft.com/office/drawing/2014/main" val="3067118971"/>
                    </a:ext>
                  </a:extLst>
                </a:gridCol>
              </a:tblGrid>
              <a:tr h="537317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zyme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ifie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tic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nt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ngth (aa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Domain(s)*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ar Localizatio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2909525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4g2106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2-1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117233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2-2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LK_141126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 &amp; Pfam 003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&amp; Golg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1574739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3g0644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3-1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085633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3-2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005178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 &amp; Pfam 003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2222425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1g2712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4-1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LK_136251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4-2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131723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 &amp; Pfam 003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5259960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1g7480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5-1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LK_105404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5-2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115741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 &amp; Pfam 003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i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44344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5g6262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6-1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IL_59_D08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6-2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IL_70_B02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 &amp; Pfam 0033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9608590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7/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T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5g5334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t1-1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007547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 0176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lg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1288829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8/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T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4g3212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t2-1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ALK_070368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176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.d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9479006"/>
                  </a:ext>
                </a:extLst>
              </a:tr>
              <a:tr h="498581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T9/ HPGT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2g2530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pgt3-1 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LK_009405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am</a:t>
                      </a: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176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.d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595" marR="72595" marT="36298" marB="36298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9848960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A60F24CA-90F2-4455-8B64-C74E2F75AFD6}"/>
              </a:ext>
            </a:extLst>
          </p:cNvPr>
          <p:cNvSpPr txBox="1"/>
          <p:nvPr/>
        </p:nvSpPr>
        <p:spPr>
          <a:xfrm>
            <a:off x="1811211" y="6268468"/>
            <a:ext cx="6097464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GALT =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am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1762; GALECTIN = pfam00337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 not determined</a:t>
            </a:r>
          </a:p>
        </p:txBody>
      </p:sp>
    </p:spTree>
    <p:extLst>
      <p:ext uri="{BB962C8B-B14F-4D97-AF65-F5344CB8AC3E}">
        <p14:creationId xmlns:p14="http://schemas.microsoft.com/office/powerpoint/2010/main" val="1715145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1365</Words>
  <Application>Microsoft Office PowerPoint</Application>
  <PresentationFormat>Widescreen</PresentationFormat>
  <Paragraphs>229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ur, Dasmeet</dc:creator>
  <cp:lastModifiedBy>Francis Frank Real</cp:lastModifiedBy>
  <cp:revision>16</cp:revision>
  <dcterms:created xsi:type="dcterms:W3CDTF">2021-10-09T23:55:20Z</dcterms:created>
  <dcterms:modified xsi:type="dcterms:W3CDTF">2021-12-09T13:20:52Z</dcterms:modified>
</cp:coreProperties>
</file>